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87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B6B5171-6163-B316-14F8-141F5AA446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021EF1F-2BD0-467D-94C9-EC19FBE9BA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11654C3-EADD-C75C-C7E2-85A785365A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DA17C1E-EA92-C74E-641B-85FA08F89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CBA34B7-83A9-4521-0B7D-190F15BD9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9309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DD1EFB8-A616-3A07-ACE5-E53FFF2646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058385F-E38E-0320-877D-BECB3E1F19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E835331-5CDB-EB75-0794-D2711D005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C84B663-4041-1E67-6A6A-9DB020824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584AA6C-C432-B460-2858-F4120DA0E5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805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6671CD5-9791-1F83-3B38-A713A84468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31CD18C-F063-AA73-7287-90BD3472BC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EF8E53F-DE49-7EFC-49F0-F900796B5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C50EE96-918A-3B8E-2A74-7B04C91081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31E8475-C186-A4F0-122C-C9AF13927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6408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7A01172-7A82-F8F4-2EB6-63DAF095F7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C28AE27-1CFA-E1A5-181F-AE43AE9A48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960FF72-8286-4380-E5D5-A8FA5F502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D10819C-434B-F511-A7A6-438F96050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1D64745-2F48-110F-3DC8-DD5A11284F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45536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705AE3C-701E-9EDB-603A-E12CE9929C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E1AD174-99E2-A263-B546-3CD9078BBA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05F3710-8D54-B05F-E14A-277403D2C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3115A2F-04C9-298A-E2B9-0B18FE7E36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9F4B85B-1C0C-1E00-5E2B-0389FDA10B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8917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5542DB-8FA4-CCBE-7168-8026241475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52D62CF-3B1B-C55F-3D0F-7E4C5D2089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B2B964E2-6D93-1292-910D-940407D91D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53C14B2-A41C-0075-B278-62AD5E34D8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08A569E-FE3E-CEF3-9FE4-DAAABF748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A2951AC-7ADE-7DCC-D94E-956BD03D5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3242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FCFBC4C-FC90-7B54-E87B-8501E04F49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6D18256-1362-8CF0-118D-0476D2A540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8A8A420-52CE-7A5B-F558-FE3C1D899C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B0E0277-0A21-562E-3DDC-DDB236BCCF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8D5601B3-A7E6-5350-3786-99D61FAFDD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6BD4EF58-1716-8A9D-0150-1F8347477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933D044D-5860-3C1C-E4C0-7C1C00521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3DF07C86-5837-6280-6C8A-CBD923425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3204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58E286-F6C8-0481-0D55-69DB696A22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2DD70A6E-7FFD-F9F1-C2B6-49B977A4B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9C781EF-693C-CC2B-87D0-DCA26BBF3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5E3DF614-731D-E15C-AFDD-5AC3EA369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0088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E07D8F8-457B-3B2C-5C34-B2D7DCF740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BB4FEE5-CAEF-9174-8F9B-A0E2DDB7E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D0777E8-36C9-3B4F-F511-CE53175C7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4304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35A26EF-1698-AD49-C047-3CE74DCE1B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6ECAD8A-F66F-D4E4-2837-7E4E77762A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57CA4DF-B950-33A8-B11F-75EA7CFCBD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1A67AEF-C465-C28F-6926-B0DA716274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67EED2C-458C-18B0-6841-350D52203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67FCF21-440A-E78C-67C3-7FEADC93C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4281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2F5E0E-ACEC-9BB7-07FE-FD37C64DE8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F67E7D10-0A01-9F7D-8092-BF3E56A12B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494E84D-BA3B-EFCE-8753-234FEC8C37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082DE44-6033-9DF0-E95D-A4A761AF6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6D066B1-371D-E2E4-9706-F5388D75A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A9D3631-CFCC-F249-C2D1-883DD05F48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74923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6B31C623-A31B-7ACC-6266-CC9F89DC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B2AFB78-089D-C48F-306F-06AFC47146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8AA6772-496C-EEB1-7B20-19CBF1D0F6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CD94444-DBAA-4BE2-8DEA-CE0DE82B7E4F}" type="datetimeFigureOut">
              <a:rPr lang="es-ES" smtClean="0"/>
              <a:t>14/0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C93749A-2132-FFEA-3AFB-805AFF8672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A82BF06-982B-9669-A503-743F3A102C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F274EF-831C-4071-859A-D40E5FCC4C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184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56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o 8">
            <a:extLst>
              <a:ext uri="{FF2B5EF4-FFF2-40B4-BE49-F238E27FC236}">
                <a16:creationId xmlns:a16="http://schemas.microsoft.com/office/drawing/2014/main" id="{24589EE9-2438-891D-F8D4-121BED38CC3B}"/>
              </a:ext>
            </a:extLst>
          </p:cNvPr>
          <p:cNvGrpSpPr/>
          <p:nvPr/>
        </p:nvGrpSpPr>
        <p:grpSpPr>
          <a:xfrm>
            <a:off x="2413262" y="108799"/>
            <a:ext cx="7230359" cy="6282573"/>
            <a:chOff x="2413262" y="108799"/>
            <a:chExt cx="7230359" cy="6282573"/>
          </a:xfrm>
        </p:grpSpPr>
        <p:sp>
          <p:nvSpPr>
            <p:cNvPr id="7" name="Rectángulo 6">
              <a:extLst>
                <a:ext uri="{FF2B5EF4-FFF2-40B4-BE49-F238E27FC236}">
                  <a16:creationId xmlns:a16="http://schemas.microsoft.com/office/drawing/2014/main" id="{F88BBB4C-016B-3E0B-E6D8-4E2C34BFC4E0}"/>
                </a:ext>
              </a:extLst>
            </p:cNvPr>
            <p:cNvSpPr/>
            <p:nvPr/>
          </p:nvSpPr>
          <p:spPr>
            <a:xfrm>
              <a:off x="2413262" y="6137634"/>
              <a:ext cx="7230359" cy="2537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8" name="Rectángulo 7">
              <a:extLst>
                <a:ext uri="{FF2B5EF4-FFF2-40B4-BE49-F238E27FC236}">
                  <a16:creationId xmlns:a16="http://schemas.microsoft.com/office/drawing/2014/main" id="{8E763416-D189-7C60-7B0D-1FEEB8F9B073}"/>
                </a:ext>
              </a:extLst>
            </p:cNvPr>
            <p:cNvSpPr/>
            <p:nvPr/>
          </p:nvSpPr>
          <p:spPr>
            <a:xfrm rot="5400000">
              <a:off x="6046112" y="2998900"/>
              <a:ext cx="6033940" cy="2537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sp>
        <p:nvSpPr>
          <p:cNvPr id="11" name="CuadroTexto 10">
            <a:extLst>
              <a:ext uri="{FF2B5EF4-FFF2-40B4-BE49-F238E27FC236}">
                <a16:creationId xmlns:a16="http://schemas.microsoft.com/office/drawing/2014/main" id="{6CC55218-7FB0-4C5F-ED54-789BE3D4ED65}"/>
              </a:ext>
            </a:extLst>
          </p:cNvPr>
          <p:cNvSpPr txBox="1"/>
          <p:nvPr/>
        </p:nvSpPr>
        <p:spPr>
          <a:xfrm>
            <a:off x="2930952" y="6137634"/>
            <a:ext cx="6005262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caffolding of the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cussatu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me through chromatin contacts obtained by Omni-C from different tissues.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id="{F4E9E8DA-1B94-E615-6F17-C5A9561560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30952" y="0"/>
            <a:ext cx="6033940" cy="60339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50364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43</TotalTime>
  <Words>20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e Office</vt:lpstr>
      <vt:lpstr>Presentación de PowerPoint</vt:lpstr>
    </vt:vector>
  </TitlesOfParts>
  <Company>Us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TINEZ PORTELA PAULINO</dc:creator>
  <cp:lastModifiedBy>MARTINEZ PORTELA PAULINO</cp:lastModifiedBy>
  <cp:revision>4</cp:revision>
  <dcterms:created xsi:type="dcterms:W3CDTF">2025-01-20T17:18:42Z</dcterms:created>
  <dcterms:modified xsi:type="dcterms:W3CDTF">2025-02-14T11:00:05Z</dcterms:modified>
</cp:coreProperties>
</file>